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864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935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656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4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76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743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674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423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70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936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050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9C58B-9423-4871-803C-9C1CB6B885EE}" type="datetimeFigureOut">
              <a:rPr lang="en-US" smtClean="0"/>
              <a:t>4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02AF3-A00B-4DD1-A970-7869B7FBB0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902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3526971" y="503852"/>
            <a:ext cx="7697755" cy="5878285"/>
            <a:chOff x="2024743" y="401216"/>
            <a:chExt cx="7697755" cy="587828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24743" y="401216"/>
              <a:ext cx="6338270" cy="5878285"/>
            </a:xfrm>
            <a:prstGeom prst="rect">
              <a:avLst/>
            </a:prstGeom>
          </p:spPr>
        </p:pic>
        <p:sp>
          <p:nvSpPr>
            <p:cNvPr id="5" name="Right Bracket 4"/>
            <p:cNvSpPr/>
            <p:nvPr/>
          </p:nvSpPr>
          <p:spPr>
            <a:xfrm>
              <a:off x="8229600" y="643812"/>
              <a:ext cx="242596" cy="1362270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ight Bracket 5"/>
            <p:cNvSpPr/>
            <p:nvPr/>
          </p:nvSpPr>
          <p:spPr>
            <a:xfrm>
              <a:off x="8296307" y="2248678"/>
              <a:ext cx="175889" cy="1063689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Bracket 6"/>
            <p:cNvSpPr/>
            <p:nvPr/>
          </p:nvSpPr>
          <p:spPr>
            <a:xfrm>
              <a:off x="8175008" y="3828661"/>
              <a:ext cx="297187" cy="715347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ight Bracket 7"/>
            <p:cNvSpPr/>
            <p:nvPr/>
          </p:nvSpPr>
          <p:spPr>
            <a:xfrm>
              <a:off x="8229600" y="4752392"/>
              <a:ext cx="242596" cy="1362270"/>
            </a:xfrm>
            <a:prstGeom prst="rightBracket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565502" y="1007707"/>
              <a:ext cx="11569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A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565502" y="2595856"/>
              <a:ext cx="11569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B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565502" y="3999339"/>
              <a:ext cx="11569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C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565502" y="5248861"/>
              <a:ext cx="11569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oup D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149291" y="401216"/>
            <a:ext cx="41241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ing of conserved type II introns found in tRNA of the chloroplast genom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9752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5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7</cp:revision>
  <dcterms:created xsi:type="dcterms:W3CDTF">2022-01-13T05:57:13Z</dcterms:created>
  <dcterms:modified xsi:type="dcterms:W3CDTF">2022-04-18T08:59:26Z</dcterms:modified>
</cp:coreProperties>
</file>